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67" r:id="rId2"/>
    <p:sldId id="264" r:id="rId3"/>
    <p:sldId id="265" r:id="rId4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A169BCD-4D1A-7A90-2A4A-13E1B4A263D9}" name="Camille Wouters" initials="CW" userId="S::cwouter1@jh.edu::7436aaca-509b-4817-8e9f-edda5b4a6481" providerId="AD"/>
  <p188:author id="{8C54ABF9-F8C2-BDDF-D662-FF7047864A24}" name="Pekosz, Andrew" initials="AP" userId="Pekosz, Andrew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800"/>
    <a:srgbClr val="727DD2"/>
    <a:srgbClr val="BE3AFF"/>
    <a:srgbClr val="E0D00C"/>
    <a:srgbClr val="3CD375"/>
    <a:srgbClr val="49FB8D"/>
    <a:srgbClr val="0001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591"/>
    <p:restoredTop sz="96296"/>
  </p:normalViewPr>
  <p:slideViewPr>
    <p:cSldViewPr snapToGrid="0">
      <p:cViewPr>
        <p:scale>
          <a:sx n="126" d="100"/>
          <a:sy n="126" d="100"/>
        </p:scale>
        <p:origin x="504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8CA54F5-EE47-6146-A09E-BD0ADC6392BD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0B89BC5-D252-584B-B0DE-934D4B63F3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71431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Example used: Flow 3, Day 0 Spike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B89BC5-D252-584B-B0DE-934D4B63F35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32799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B89BC5-D252-584B-B0DE-934D4B63F35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2960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B89BC5-D252-584B-B0DE-934D4B63F35A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6472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114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603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9485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790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538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007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392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480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7065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9647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2751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318C2-2328-7540-97CE-E25C467DC90E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C1D69-9CB7-764A-BFBC-95F1711F9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5702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18" Type="http://schemas.openxmlformats.org/officeDocument/2006/relationships/image" Target="../media/image1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10" Type="http://schemas.openxmlformats.org/officeDocument/2006/relationships/image" Target="../media/image26.emf"/><Relationship Id="rId4" Type="http://schemas.openxmlformats.org/officeDocument/2006/relationships/image" Target="../media/image20.emf"/><Relationship Id="rId9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72B7B92-F660-A14B-B6C2-28860F182A54}"/>
              </a:ext>
            </a:extLst>
          </p:cNvPr>
          <p:cNvSpPr txBox="1"/>
          <p:nvPr/>
        </p:nvSpPr>
        <p:spPr>
          <a:xfrm>
            <a:off x="255095" y="483664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C1792CC-D22E-99D5-80FF-DC096FDD9C7B}"/>
              </a:ext>
            </a:extLst>
          </p:cNvPr>
          <p:cNvSpPr txBox="1"/>
          <p:nvPr/>
        </p:nvSpPr>
        <p:spPr>
          <a:xfrm>
            <a:off x="103180" y="78822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endParaRPr lang="en-GB" b="1" dirty="0">
              <a:highlight>
                <a:srgbClr val="FFFF00"/>
              </a:highlight>
            </a:endParaRPr>
          </a:p>
        </p:txBody>
      </p:sp>
      <p:pic>
        <p:nvPicPr>
          <p:cNvPr id="11" name="Picture 10" descr="A collage of graphs&#10;&#10;Description automatically generated">
            <a:extLst>
              <a:ext uri="{FF2B5EF4-FFF2-40B4-BE49-F238E27FC236}">
                <a16:creationId xmlns:a16="http://schemas.microsoft.com/office/drawing/2014/main" id="{FC9F58BF-A223-2E1E-562B-558879E4D8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502" y="972887"/>
            <a:ext cx="5632996" cy="3431867"/>
          </a:xfrm>
          <a:prstGeom prst="rect">
            <a:avLst/>
          </a:prstGeom>
        </p:spPr>
      </p:pic>
      <p:pic>
        <p:nvPicPr>
          <p:cNvPr id="13" name="Picture 12" descr="A black background with colorful text&#10;&#10;Description automatically generated">
            <a:extLst>
              <a:ext uri="{FF2B5EF4-FFF2-40B4-BE49-F238E27FC236}">
                <a16:creationId xmlns:a16="http://schemas.microsoft.com/office/drawing/2014/main" id="{061B13DE-C475-F46F-0EF5-DBD1FBB8CB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55302" y="4384415"/>
            <a:ext cx="6400800" cy="29083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C24FB95-0E91-F1E5-575E-7AEB2D965FCA}"/>
              </a:ext>
            </a:extLst>
          </p:cNvPr>
          <p:cNvSpPr txBox="1"/>
          <p:nvPr/>
        </p:nvSpPr>
        <p:spPr>
          <a:xfrm>
            <a:off x="-31555" y="7759005"/>
            <a:ext cx="692110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S1: Flow cytometry gating strategy and results. </a:t>
            </a:r>
            <a:r>
              <a:rPr lang="en-GB" sz="1200" dirty="0"/>
              <a:t>A: Total cells were sequentially gated for debris exclusion, single cells and live cells (which do not take up the Live/Dead Fixable Aqua Dead Cell Stain), before gating for Spike positive cells. B: Mean percentage and Mean Fluorescence Intensity of cells positive for surface Spike for each </a:t>
            </a:r>
            <a:r>
              <a:rPr lang="en-GB" sz="1200" dirty="0" err="1"/>
              <a:t>pCAGGS</a:t>
            </a:r>
            <a:r>
              <a:rPr lang="en-GB" sz="1200" dirty="0"/>
              <a:t>-Spike plasmid, averaged from 5 independent flow cytometry experiments, </a:t>
            </a:r>
            <a:r>
              <a:rPr lang="en-GB" sz="12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sym typeface="Symbol" pitchFamily="2" charset="2"/>
              </a:rPr>
              <a:t></a:t>
            </a:r>
            <a:r>
              <a:rPr lang="en-GB" sz="1200" dirty="0">
                <a:effectLst/>
              </a:rPr>
              <a:t> standard deviation</a:t>
            </a:r>
            <a:r>
              <a:rPr lang="en-GB" sz="1200" dirty="0"/>
              <a:t>. One-way repeated measures ANOVA with Bonferroni's multiple comparisons test (* p &lt; 0.05) was performed on the data set and no significant differences were found between percent live Spike positive cells or MFI between Spike-</a:t>
            </a:r>
            <a:r>
              <a:rPr lang="en-GB" sz="1200" dirty="0" err="1"/>
              <a:t>pCAGGS</a:t>
            </a:r>
            <a:r>
              <a:rPr lang="en-GB" sz="1200" dirty="0"/>
              <a:t> plasmids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944158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1FC5AB-B7CF-5529-18EE-13551D347C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ight Bracket 1">
            <a:extLst>
              <a:ext uri="{FF2B5EF4-FFF2-40B4-BE49-F238E27FC236}">
                <a16:creationId xmlns:a16="http://schemas.microsoft.com/office/drawing/2014/main" id="{EF4CCDE0-1B54-5682-F6D4-5D81BBEE0CEC}"/>
              </a:ext>
            </a:extLst>
          </p:cNvPr>
          <p:cNvSpPr/>
          <p:nvPr/>
        </p:nvSpPr>
        <p:spPr>
          <a:xfrm rot="10800000">
            <a:off x="431440" y="823355"/>
            <a:ext cx="233885" cy="1298671"/>
          </a:xfrm>
          <a:prstGeom prst="rightBracket">
            <a:avLst/>
          </a:prstGeom>
          <a:ln w="9525">
            <a:solidFill>
              <a:srgbClr val="0001E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1015183-7125-4EED-C083-CEC591A50F69}"/>
              </a:ext>
            </a:extLst>
          </p:cNvPr>
          <p:cNvSpPr txBox="1"/>
          <p:nvPr/>
        </p:nvSpPr>
        <p:spPr>
          <a:xfrm rot="16200000">
            <a:off x="-164720" y="1288024"/>
            <a:ext cx="760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1E0"/>
                </a:solidFill>
              </a:rPr>
              <a:t>Day 0 </a:t>
            </a:r>
          </a:p>
        </p:txBody>
      </p:sp>
      <p:sp>
        <p:nvSpPr>
          <p:cNvPr id="7" name="Right Bracket 6">
            <a:extLst>
              <a:ext uri="{FF2B5EF4-FFF2-40B4-BE49-F238E27FC236}">
                <a16:creationId xmlns:a16="http://schemas.microsoft.com/office/drawing/2014/main" id="{BE77D82B-B153-105F-0BCB-1FA679CB632C}"/>
              </a:ext>
            </a:extLst>
          </p:cNvPr>
          <p:cNvSpPr/>
          <p:nvPr/>
        </p:nvSpPr>
        <p:spPr>
          <a:xfrm rot="10800000">
            <a:off x="431440" y="2587579"/>
            <a:ext cx="233885" cy="1298671"/>
          </a:xfrm>
          <a:prstGeom prst="rightBracket">
            <a:avLst/>
          </a:prstGeom>
          <a:ln w="9525">
            <a:solidFill>
              <a:srgbClr val="49FB8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3CD375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3EAD9E-D880-034E-3B56-C4586B65E259}"/>
              </a:ext>
            </a:extLst>
          </p:cNvPr>
          <p:cNvSpPr txBox="1"/>
          <p:nvPr/>
        </p:nvSpPr>
        <p:spPr>
          <a:xfrm rot="16200000">
            <a:off x="-243781" y="3020595"/>
            <a:ext cx="99469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3CD375"/>
                </a:solidFill>
              </a:rPr>
              <a:t>Day 134 </a:t>
            </a:r>
          </a:p>
        </p:txBody>
      </p:sp>
      <p:sp>
        <p:nvSpPr>
          <p:cNvPr id="9" name="Right Bracket 8">
            <a:extLst>
              <a:ext uri="{FF2B5EF4-FFF2-40B4-BE49-F238E27FC236}">
                <a16:creationId xmlns:a16="http://schemas.microsoft.com/office/drawing/2014/main" id="{AC5602B3-0041-5369-92AC-78978379F675}"/>
              </a:ext>
            </a:extLst>
          </p:cNvPr>
          <p:cNvSpPr/>
          <p:nvPr/>
        </p:nvSpPr>
        <p:spPr>
          <a:xfrm rot="10800000">
            <a:off x="438233" y="4417675"/>
            <a:ext cx="233885" cy="1298671"/>
          </a:xfrm>
          <a:prstGeom prst="rightBracket">
            <a:avLst/>
          </a:prstGeom>
          <a:ln w="9525">
            <a:solidFill>
              <a:srgbClr val="E0D00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E0D00C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2203A9-88F9-B833-978A-8FBDA7221C82}"/>
              </a:ext>
            </a:extLst>
          </p:cNvPr>
          <p:cNvSpPr txBox="1"/>
          <p:nvPr/>
        </p:nvSpPr>
        <p:spPr>
          <a:xfrm rot="16200000">
            <a:off x="-210538" y="4850691"/>
            <a:ext cx="94179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accent4">
                    <a:lumMod val="75000"/>
                  </a:schemeClr>
                </a:solidFill>
              </a:rPr>
              <a:t>Day 137</a:t>
            </a:r>
          </a:p>
        </p:txBody>
      </p:sp>
      <p:sp>
        <p:nvSpPr>
          <p:cNvPr id="11" name="Right Bracket 10">
            <a:extLst>
              <a:ext uri="{FF2B5EF4-FFF2-40B4-BE49-F238E27FC236}">
                <a16:creationId xmlns:a16="http://schemas.microsoft.com/office/drawing/2014/main" id="{C429FCB7-4F7B-B85F-BCAF-7B15DBBBE07F}"/>
              </a:ext>
            </a:extLst>
          </p:cNvPr>
          <p:cNvSpPr/>
          <p:nvPr/>
        </p:nvSpPr>
        <p:spPr>
          <a:xfrm rot="10800000">
            <a:off x="445026" y="6181899"/>
            <a:ext cx="233885" cy="1298671"/>
          </a:xfrm>
          <a:prstGeom prst="rightBracket">
            <a:avLst/>
          </a:prstGeom>
          <a:ln w="9525">
            <a:solidFill>
              <a:srgbClr val="BE3A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3CD375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A1DAD0-5B46-91A9-B946-6ABCC04E8608}"/>
              </a:ext>
            </a:extLst>
          </p:cNvPr>
          <p:cNvSpPr txBox="1"/>
          <p:nvPr/>
        </p:nvSpPr>
        <p:spPr>
          <a:xfrm rot="16200000">
            <a:off x="-230195" y="6614915"/>
            <a:ext cx="99469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BE3AFF"/>
                </a:solidFill>
              </a:rPr>
              <a:t>Day 144 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A00ECBA-30D9-69CB-3CB3-4F4675F306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756" y="884809"/>
            <a:ext cx="1928163" cy="123402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D9646B6-9677-BA7F-C48A-08E68D8B12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87135" y="804723"/>
            <a:ext cx="1183871" cy="121789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F7D34CD-210E-A0D9-DD6E-92054F5925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4064" y="2582202"/>
            <a:ext cx="2114763" cy="135344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D9A7BE7-760C-388D-FFF7-8476D656EDF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87135" y="2497023"/>
            <a:ext cx="1262395" cy="129867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5F0D56A0-5F1C-B96E-C02C-DD3A03FFA6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4911" y="4490275"/>
            <a:ext cx="2114763" cy="135344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386D7C9-0417-7DE6-81F5-7FED11937D5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48827" y="4433508"/>
            <a:ext cx="1200703" cy="1235206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3509589-BB8C-9498-52B2-B20576BD110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89773" y="6306528"/>
            <a:ext cx="1118810" cy="115096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A4A6087-96CC-F543-A1AB-90E697A992B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56780" y="6228636"/>
            <a:ext cx="2114763" cy="138941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C4DF632-C49C-6E41-CCEB-389F94862FF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771006" y="763770"/>
            <a:ext cx="2117698" cy="139470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F59898D-E838-CF77-8773-2F826EA4DF6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87893" y="814039"/>
            <a:ext cx="1070107" cy="119925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4F2CCDC3-6275-DB5A-A20E-3C50B161EB1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808583" y="2534669"/>
            <a:ext cx="2199397" cy="144851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91A8278-DA97-84FD-F468-798E208B0E5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88704" y="2608707"/>
            <a:ext cx="1070106" cy="119310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8A6AF13F-47A7-1104-3DC0-E293EB0155C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830461" y="4480221"/>
            <a:ext cx="2199397" cy="1448513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C961D64A-3409-101A-FC82-BB23FEAD08A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906400" y="4558039"/>
            <a:ext cx="1070106" cy="1193107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9A407B3F-5B31-C7B4-4BA3-F11C65670FD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880852" y="6184775"/>
            <a:ext cx="2199397" cy="1448513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6891BFF4-C4C2-8D98-3A27-FC32CD0907E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990303" y="6302233"/>
            <a:ext cx="1045913" cy="1166132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97A8CA1-E050-1598-AAAE-3ABE17B0B0D9}"/>
              </a:ext>
            </a:extLst>
          </p:cNvPr>
          <p:cNvSpPr txBox="1"/>
          <p:nvPr/>
        </p:nvSpPr>
        <p:spPr>
          <a:xfrm>
            <a:off x="1181826" y="315443"/>
            <a:ext cx="16666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Vero/TMPRSS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800EF56-96F9-C37F-8FB8-07C35C4FCF61}"/>
              </a:ext>
            </a:extLst>
          </p:cNvPr>
          <p:cNvSpPr txBox="1"/>
          <p:nvPr/>
        </p:nvSpPr>
        <p:spPr>
          <a:xfrm>
            <a:off x="4601729" y="340532"/>
            <a:ext cx="1401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hNE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6FCE16C-50D5-8858-5051-4BF322E7D538}"/>
              </a:ext>
            </a:extLst>
          </p:cNvPr>
          <p:cNvSpPr txBox="1"/>
          <p:nvPr/>
        </p:nvSpPr>
        <p:spPr>
          <a:xfrm>
            <a:off x="0" y="7648910"/>
            <a:ext cx="685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ementary Figure S2: Patient 2 isolates show temperature-dependent differences in virus replication over time and total virus production.</a:t>
            </a:r>
            <a:r>
              <a:rPr lang="en-GB" sz="1000" dirty="0"/>
              <a:t> p values displayed as: “ns” p &gt; 0.05, ), * p &lt; 0.05, ** p &lt; 0.01, *** p &lt; 0.001, ****p &lt;0.0001.</a:t>
            </a:r>
            <a:endParaRPr lang="en-GB" sz="1000" b="1" dirty="0"/>
          </a:p>
          <a:p>
            <a:r>
              <a:rPr lang="en-GB" sz="1000" dirty="0"/>
              <a:t>A, E, I, M: Growth curves showing virus replication on Vero/TMPRSS2 cells at 33</a:t>
            </a:r>
            <a:r>
              <a:rPr lang="en-GB" sz="1000" baseline="30000" dirty="0"/>
              <a:t>o</a:t>
            </a:r>
            <a:r>
              <a:rPr lang="en-GB" sz="1000" dirty="0"/>
              <a:t>C and 37</a:t>
            </a:r>
            <a:r>
              <a:rPr lang="en-GB" sz="1000" baseline="30000" dirty="0"/>
              <a:t>o</a:t>
            </a:r>
            <a:r>
              <a:rPr lang="en-GB" sz="1000" dirty="0"/>
              <a:t>C respectively, 3 independent experiments with four wells per virus per experiment, standard deviation shown on error bars, two-way repeated measures ANOVA with Bonferroni's multiple comparisons test.</a:t>
            </a:r>
          </a:p>
          <a:p>
            <a:r>
              <a:rPr lang="en-GB" sz="1000" dirty="0"/>
              <a:t>B, F, J, N: : Total virus production on Vero/TMPRSS2 cells measured until point of replication curve overlap (36 HPI), unpaired t test.</a:t>
            </a:r>
          </a:p>
          <a:p>
            <a:r>
              <a:rPr lang="en-GB" sz="1000" dirty="0"/>
              <a:t>C, G, K, O: Growth curves on hNECs at 33</a:t>
            </a:r>
            <a:r>
              <a:rPr lang="en-GB" sz="1000" baseline="30000" dirty="0"/>
              <a:t>o</a:t>
            </a:r>
            <a:r>
              <a:rPr lang="en-GB" sz="1000" dirty="0"/>
              <a:t>C and 37</a:t>
            </a:r>
            <a:r>
              <a:rPr lang="en-GB" sz="1000" baseline="30000" dirty="0"/>
              <a:t>o</a:t>
            </a:r>
            <a:r>
              <a:rPr lang="en-GB" sz="1000" dirty="0"/>
              <a:t>C respectively, 3 independent experiments, standard deviation shown on error bars, two-way repeated measures ANOVA with Bonferroni's multiple comparisons test.</a:t>
            </a:r>
          </a:p>
          <a:p>
            <a:r>
              <a:rPr lang="en-GB" sz="1000" dirty="0"/>
              <a:t>D, H, L, P: Total virus production on hNECs measured until point of replication curve overlap (72 HPI), unpaired t test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F6700F2-8093-8BED-7F5F-ADB73F38629E}"/>
              </a:ext>
            </a:extLst>
          </p:cNvPr>
          <p:cNvSpPr txBox="1"/>
          <p:nvPr/>
        </p:nvSpPr>
        <p:spPr>
          <a:xfrm>
            <a:off x="683788" y="5076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73E3CC0-47A0-580A-85B7-A547CB8A682D}"/>
              </a:ext>
            </a:extLst>
          </p:cNvPr>
          <p:cNvSpPr txBox="1"/>
          <p:nvPr/>
        </p:nvSpPr>
        <p:spPr>
          <a:xfrm>
            <a:off x="2538775" y="52437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BD7F4CB-2636-9B96-E4F1-308EF62C0998}"/>
              </a:ext>
            </a:extLst>
          </p:cNvPr>
          <p:cNvSpPr txBox="1"/>
          <p:nvPr/>
        </p:nvSpPr>
        <p:spPr>
          <a:xfrm>
            <a:off x="3759363" y="51682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36DA283-9A29-F79E-0AFD-D95B2DBAB8B7}"/>
              </a:ext>
            </a:extLst>
          </p:cNvPr>
          <p:cNvSpPr txBox="1"/>
          <p:nvPr/>
        </p:nvSpPr>
        <p:spPr>
          <a:xfrm>
            <a:off x="5670265" y="55452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BA8C1CD-E7AB-6732-37C7-126069CEC668}"/>
              </a:ext>
            </a:extLst>
          </p:cNvPr>
          <p:cNvSpPr txBox="1"/>
          <p:nvPr/>
        </p:nvSpPr>
        <p:spPr>
          <a:xfrm>
            <a:off x="693344" y="2301133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6AA0081-5675-44DA-E0AC-E49DBFE4D561}"/>
              </a:ext>
            </a:extLst>
          </p:cNvPr>
          <p:cNvSpPr txBox="1"/>
          <p:nvPr/>
        </p:nvSpPr>
        <p:spPr>
          <a:xfrm>
            <a:off x="2463643" y="230886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2D99E45-BFE7-7C28-A48D-8C830555B13F}"/>
              </a:ext>
            </a:extLst>
          </p:cNvPr>
          <p:cNvSpPr txBox="1"/>
          <p:nvPr/>
        </p:nvSpPr>
        <p:spPr>
          <a:xfrm>
            <a:off x="3658705" y="2316999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25B9BE4-4EC3-428E-9376-AD3E17F1455C}"/>
              </a:ext>
            </a:extLst>
          </p:cNvPr>
          <p:cNvSpPr txBox="1"/>
          <p:nvPr/>
        </p:nvSpPr>
        <p:spPr>
          <a:xfrm>
            <a:off x="5677800" y="228965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E0916D0-B61F-A353-09D1-BD3CA4218A12}"/>
              </a:ext>
            </a:extLst>
          </p:cNvPr>
          <p:cNvSpPr txBox="1"/>
          <p:nvPr/>
        </p:nvSpPr>
        <p:spPr>
          <a:xfrm>
            <a:off x="720595" y="4188707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6E8AA43-575F-6465-63C4-2A3F100994D9}"/>
              </a:ext>
            </a:extLst>
          </p:cNvPr>
          <p:cNvSpPr txBox="1"/>
          <p:nvPr/>
        </p:nvSpPr>
        <p:spPr>
          <a:xfrm>
            <a:off x="2580472" y="4208990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J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FC7E85E-A6A1-B5BD-B732-A1AB7469C25C}"/>
              </a:ext>
            </a:extLst>
          </p:cNvPr>
          <p:cNvSpPr txBox="1"/>
          <p:nvPr/>
        </p:nvSpPr>
        <p:spPr>
          <a:xfrm>
            <a:off x="3808583" y="4211667"/>
            <a:ext cx="3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K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2F95FED-B688-23E2-8693-AA39DF466A94}"/>
              </a:ext>
            </a:extLst>
          </p:cNvPr>
          <p:cNvSpPr txBox="1"/>
          <p:nvPr/>
        </p:nvSpPr>
        <p:spPr>
          <a:xfrm>
            <a:off x="5817168" y="4235443"/>
            <a:ext cx="3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D37E9A6-1E90-1AFC-A096-DE06F50CEDAA}"/>
              </a:ext>
            </a:extLst>
          </p:cNvPr>
          <p:cNvSpPr txBox="1"/>
          <p:nvPr/>
        </p:nvSpPr>
        <p:spPr>
          <a:xfrm>
            <a:off x="672118" y="5948259"/>
            <a:ext cx="3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93757DB-A6DF-0A1C-611E-0368BA65C03F}"/>
              </a:ext>
            </a:extLst>
          </p:cNvPr>
          <p:cNvSpPr txBox="1"/>
          <p:nvPr/>
        </p:nvSpPr>
        <p:spPr>
          <a:xfrm>
            <a:off x="2695105" y="5911899"/>
            <a:ext cx="3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26987BD-6C82-6DAF-1F3B-AD79752087DD}"/>
              </a:ext>
            </a:extLst>
          </p:cNvPr>
          <p:cNvSpPr txBox="1"/>
          <p:nvPr/>
        </p:nvSpPr>
        <p:spPr>
          <a:xfrm>
            <a:off x="3797644" y="5920112"/>
            <a:ext cx="3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O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5998259-74D1-F771-0044-3403BBA1FF4B}"/>
              </a:ext>
            </a:extLst>
          </p:cNvPr>
          <p:cNvSpPr txBox="1"/>
          <p:nvPr/>
        </p:nvSpPr>
        <p:spPr>
          <a:xfrm>
            <a:off x="5845779" y="5896402"/>
            <a:ext cx="3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92512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C8F694-581B-9746-24AD-AB2DD81F53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ight Bracket 1">
            <a:extLst>
              <a:ext uri="{FF2B5EF4-FFF2-40B4-BE49-F238E27FC236}">
                <a16:creationId xmlns:a16="http://schemas.microsoft.com/office/drawing/2014/main" id="{D3D7879A-DB7E-FC97-A742-C34C2CCCEF47}"/>
              </a:ext>
            </a:extLst>
          </p:cNvPr>
          <p:cNvSpPr/>
          <p:nvPr/>
        </p:nvSpPr>
        <p:spPr>
          <a:xfrm rot="10800000">
            <a:off x="431440" y="823355"/>
            <a:ext cx="233885" cy="1298671"/>
          </a:xfrm>
          <a:prstGeom prst="rightBracket">
            <a:avLst/>
          </a:prstGeom>
          <a:ln w="9525">
            <a:solidFill>
              <a:srgbClr val="727DD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D5B0FA9-1033-6E46-5AAE-9B6F9C1F9D2C}"/>
              </a:ext>
            </a:extLst>
          </p:cNvPr>
          <p:cNvSpPr txBox="1"/>
          <p:nvPr/>
        </p:nvSpPr>
        <p:spPr>
          <a:xfrm rot="16200000">
            <a:off x="-164720" y="1288024"/>
            <a:ext cx="760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727DD2"/>
                </a:solidFill>
              </a:rPr>
              <a:t>Day 0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452293-E3DA-2CFA-D131-F1216E6782A4}"/>
              </a:ext>
            </a:extLst>
          </p:cNvPr>
          <p:cNvSpPr txBox="1"/>
          <p:nvPr/>
        </p:nvSpPr>
        <p:spPr>
          <a:xfrm>
            <a:off x="1181826" y="315443"/>
            <a:ext cx="16666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Vero/TMPRSS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8236A7-9307-FAF8-FE73-4F1E28DE3A49}"/>
              </a:ext>
            </a:extLst>
          </p:cNvPr>
          <p:cNvSpPr txBox="1"/>
          <p:nvPr/>
        </p:nvSpPr>
        <p:spPr>
          <a:xfrm>
            <a:off x="4601729" y="340532"/>
            <a:ext cx="14018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hNEC</a:t>
            </a:r>
          </a:p>
        </p:txBody>
      </p:sp>
      <p:sp>
        <p:nvSpPr>
          <p:cNvPr id="7" name="Right Bracket 6">
            <a:extLst>
              <a:ext uri="{FF2B5EF4-FFF2-40B4-BE49-F238E27FC236}">
                <a16:creationId xmlns:a16="http://schemas.microsoft.com/office/drawing/2014/main" id="{231B22C5-8E36-3592-9946-2FAB9E23E3CB}"/>
              </a:ext>
            </a:extLst>
          </p:cNvPr>
          <p:cNvSpPr/>
          <p:nvPr/>
        </p:nvSpPr>
        <p:spPr>
          <a:xfrm rot="10800000">
            <a:off x="431440" y="2587579"/>
            <a:ext cx="233885" cy="1298671"/>
          </a:xfrm>
          <a:prstGeom prst="rightBracket">
            <a:avLst/>
          </a:prstGeom>
          <a:ln w="9525">
            <a:solidFill>
              <a:srgbClr val="FFA8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3CD375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C7C8FE-219D-FFE2-2F55-9EE7FB2986CB}"/>
              </a:ext>
            </a:extLst>
          </p:cNvPr>
          <p:cNvSpPr txBox="1"/>
          <p:nvPr/>
        </p:nvSpPr>
        <p:spPr>
          <a:xfrm rot="16200000">
            <a:off x="-243781" y="3020595"/>
            <a:ext cx="99469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accent2">
                    <a:lumMod val="75000"/>
                  </a:schemeClr>
                </a:solidFill>
              </a:rPr>
              <a:t>Day 139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ABD0707-3456-1579-32D3-A456E9B57C40}"/>
              </a:ext>
            </a:extLst>
          </p:cNvPr>
          <p:cNvSpPr txBox="1"/>
          <p:nvPr/>
        </p:nvSpPr>
        <p:spPr>
          <a:xfrm>
            <a:off x="68901" y="4171890"/>
            <a:ext cx="679611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ementary </a:t>
            </a:r>
            <a:r>
              <a:rPr lang="en-GB" sz="1000" b="1"/>
              <a:t>Figure S3</a:t>
            </a:r>
            <a:r>
              <a:rPr lang="en-GB" sz="1000" b="1" dirty="0"/>
              <a:t>: Patient 3 isolates show temperature-dependent differences in virus replication over time and total virus production.</a:t>
            </a:r>
            <a:r>
              <a:rPr lang="en-GB" sz="1000" dirty="0"/>
              <a:t> p values displayed as: “ns” p &gt; 0.05, ), * p &lt; 0.05, ** p &lt; 0.01, *** p &lt; 0.001, ****p &lt;0.0001.</a:t>
            </a:r>
            <a:endParaRPr lang="en-GB" sz="1000" b="1" dirty="0"/>
          </a:p>
          <a:p>
            <a:r>
              <a:rPr lang="en-GB" sz="1000" dirty="0"/>
              <a:t>A, E: Growth curves showing virus replication on Vero/TMPRSS2 cells at 33</a:t>
            </a:r>
            <a:r>
              <a:rPr lang="en-GB" sz="1000" baseline="30000" dirty="0"/>
              <a:t>o</a:t>
            </a:r>
            <a:r>
              <a:rPr lang="en-GB" sz="1000" dirty="0"/>
              <a:t>C and 37</a:t>
            </a:r>
            <a:r>
              <a:rPr lang="en-GB" sz="1000" baseline="30000" dirty="0"/>
              <a:t>o</a:t>
            </a:r>
            <a:r>
              <a:rPr lang="en-GB" sz="1000" dirty="0"/>
              <a:t>C respectively, 3 independent experiments with four wells per virus per experiment, standard deviation shown on error bars, two-way repeated measures ANOVA with Bonferroni's multiple comparisons test.</a:t>
            </a:r>
          </a:p>
          <a:p>
            <a:r>
              <a:rPr lang="en-GB" sz="1000" dirty="0"/>
              <a:t>B, F: : Total virus production on Vero/TMPRSS2 cells measured until point of replication curve overlap (36 HPI), unpaired t test.</a:t>
            </a:r>
          </a:p>
          <a:p>
            <a:r>
              <a:rPr lang="en-GB" sz="1000" dirty="0"/>
              <a:t>C, G: Growth curves on hNECs at 33</a:t>
            </a:r>
            <a:r>
              <a:rPr lang="en-GB" sz="1000" baseline="30000" dirty="0"/>
              <a:t>o</a:t>
            </a:r>
            <a:r>
              <a:rPr lang="en-GB" sz="1000" dirty="0"/>
              <a:t>C and 37</a:t>
            </a:r>
            <a:r>
              <a:rPr lang="en-GB" sz="1000" baseline="30000" dirty="0"/>
              <a:t>o</a:t>
            </a:r>
            <a:r>
              <a:rPr lang="en-GB" sz="1000" dirty="0"/>
              <a:t>C respectively, 3 independent experiments, standard deviation shown on error bars, two-way repeated measures ANOVA with Bonferroni's multiple comparisons test.</a:t>
            </a:r>
          </a:p>
          <a:p>
            <a:r>
              <a:rPr lang="en-GB" sz="1000" dirty="0"/>
              <a:t>D, H: Total virus production on hNECs measured until point of replication curve overlap (72 HPI), unpaired t test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CBCA9FF-DF48-07D9-6E80-D4757356B19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3431"/>
          <a:stretch/>
        </p:blipFill>
        <p:spPr>
          <a:xfrm>
            <a:off x="3767319" y="756753"/>
            <a:ext cx="2048135" cy="134636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64B4758-8833-D6A6-E925-37EA284ED5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6472" y="2723281"/>
            <a:ext cx="2044296" cy="134636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0E50369-D8D4-8923-463E-C918953071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76140" y="854161"/>
            <a:ext cx="1090115" cy="121541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B9E3E8E-A68A-F48C-159D-803584D824B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06412" y="2633818"/>
            <a:ext cx="1123315" cy="125243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7AF1BBE-BCEB-70D8-686D-E61B07A158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15454" y="797130"/>
            <a:ext cx="1049563" cy="117020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AC83A5E-182C-1886-3300-F89C73B8C53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15454" y="2694278"/>
            <a:ext cx="1112477" cy="124034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6391E95-D2C0-6127-B8C6-5DEDF6AD90E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7325" y="919928"/>
            <a:ext cx="1899087" cy="121541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3A6049E-FFA8-5DB0-2666-019C52BFD00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38605" y="2763776"/>
            <a:ext cx="1827292" cy="118666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78D7189C-E878-7B5E-0695-6A2F761334B5}"/>
              </a:ext>
            </a:extLst>
          </p:cNvPr>
          <p:cNvSpPr txBox="1"/>
          <p:nvPr/>
        </p:nvSpPr>
        <p:spPr>
          <a:xfrm>
            <a:off x="696491" y="59244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95DDFBA-C650-98E2-4A15-B77D1680C370}"/>
              </a:ext>
            </a:extLst>
          </p:cNvPr>
          <p:cNvSpPr txBox="1"/>
          <p:nvPr/>
        </p:nvSpPr>
        <p:spPr>
          <a:xfrm>
            <a:off x="2521441" y="62505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BE87506-145D-057F-C77D-CF3EBCE10D0E}"/>
              </a:ext>
            </a:extLst>
          </p:cNvPr>
          <p:cNvSpPr txBox="1"/>
          <p:nvPr/>
        </p:nvSpPr>
        <p:spPr>
          <a:xfrm>
            <a:off x="3571053" y="61837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29EE87F-0280-20C1-9357-680BF2D8B489}"/>
              </a:ext>
            </a:extLst>
          </p:cNvPr>
          <p:cNvSpPr txBox="1"/>
          <p:nvPr/>
        </p:nvSpPr>
        <p:spPr>
          <a:xfrm>
            <a:off x="5684386" y="62505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0F32C0A-BAF7-A9C5-BC75-84FCCE885343}"/>
              </a:ext>
            </a:extLst>
          </p:cNvPr>
          <p:cNvSpPr txBox="1"/>
          <p:nvPr/>
        </p:nvSpPr>
        <p:spPr>
          <a:xfrm>
            <a:off x="705841" y="248678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CCCDE4D-3339-42A0-AFE2-C1BDD0D7F3D6}"/>
              </a:ext>
            </a:extLst>
          </p:cNvPr>
          <p:cNvSpPr txBox="1"/>
          <p:nvPr/>
        </p:nvSpPr>
        <p:spPr>
          <a:xfrm>
            <a:off x="2476140" y="249451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3B45220-07BF-F507-0957-5F7F864166DF}"/>
              </a:ext>
            </a:extLst>
          </p:cNvPr>
          <p:cNvSpPr txBox="1"/>
          <p:nvPr/>
        </p:nvSpPr>
        <p:spPr>
          <a:xfrm>
            <a:off x="3671202" y="250265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C728932-BF54-97B1-4B43-2B40AAE2AA5B}"/>
              </a:ext>
            </a:extLst>
          </p:cNvPr>
          <p:cNvSpPr txBox="1"/>
          <p:nvPr/>
        </p:nvSpPr>
        <p:spPr>
          <a:xfrm>
            <a:off x="5690297" y="247530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1271320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260</TotalTime>
  <Words>569</Words>
  <Application>Microsoft Macintosh PowerPoint</Application>
  <PresentationFormat>Letter Paper (8.5x11 in)</PresentationFormat>
  <Paragraphs>51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LA Figures Outline</dc:title>
  <dc:creator>Camille Wouters</dc:creator>
  <cp:lastModifiedBy>Camille Wouters</cp:lastModifiedBy>
  <cp:revision>24</cp:revision>
  <cp:lastPrinted>2024-01-08T14:29:42Z</cp:lastPrinted>
  <dcterms:created xsi:type="dcterms:W3CDTF">2023-01-12T16:15:31Z</dcterms:created>
  <dcterms:modified xsi:type="dcterms:W3CDTF">2024-09-13T15:32:41Z</dcterms:modified>
</cp:coreProperties>
</file>